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02" y="2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87BD38-5425-4E10-B2C2-B316307986D0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5E75D0-2C0A-4F25-8697-4559D697B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3743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2260A1-EC86-4C16-AC03-E4807241191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9300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07CC7-650A-4BC8-9BCD-741B2004808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DB463-1FF6-4946-A612-197D19C48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541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07CC7-650A-4BC8-9BCD-741B2004808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DB463-1FF6-4946-A612-197D19C48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016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07CC7-650A-4BC8-9BCD-741B2004808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DB463-1FF6-4946-A612-197D19C48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916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07CC7-650A-4BC8-9BCD-741B2004808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DB463-1FF6-4946-A612-197D19C48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508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07CC7-650A-4BC8-9BCD-741B2004808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DB463-1FF6-4946-A612-197D19C48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7777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07CC7-650A-4BC8-9BCD-741B2004808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DB463-1FF6-4946-A612-197D19C48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405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07CC7-650A-4BC8-9BCD-741B2004808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DB463-1FF6-4946-A612-197D19C48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170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07CC7-650A-4BC8-9BCD-741B2004808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DB463-1FF6-4946-A612-197D19C48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800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07CC7-650A-4BC8-9BCD-741B2004808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DB463-1FF6-4946-A612-197D19C48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064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07CC7-650A-4BC8-9BCD-741B2004808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DB463-1FF6-4946-A612-197D19C48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727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07CC7-650A-4BC8-9BCD-741B2004808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DB463-1FF6-4946-A612-197D19C48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185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C07CC7-650A-4BC8-9BCD-741B2004808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CDB463-1FF6-4946-A612-197D19C48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953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4517363" y="1017004"/>
            <a:ext cx="2831513" cy="3696772"/>
            <a:chOff x="1148747" y="1469008"/>
            <a:chExt cx="4089961" cy="533978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4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851697" y="1923117"/>
              <a:ext cx="2886478" cy="1543265"/>
            </a:xfrm>
            <a:prstGeom prst="rect">
              <a:avLst/>
            </a:prstGeom>
          </p:spPr>
        </p:pic>
        <p:grpSp>
          <p:nvGrpSpPr>
            <p:cNvPr id="4" name="组合 3"/>
            <p:cNvGrpSpPr/>
            <p:nvPr/>
          </p:nvGrpSpPr>
          <p:grpSpPr>
            <a:xfrm>
              <a:off x="3163820" y="2760661"/>
              <a:ext cx="582350" cy="839294"/>
              <a:chOff x="4202079" y="3231831"/>
              <a:chExt cx="582350" cy="839294"/>
            </a:xfrm>
          </p:grpSpPr>
          <p:cxnSp>
            <p:nvCxnSpPr>
              <p:cNvPr id="52" name="直接连接符 51">
                <a:extLst>
                  <a:ext uri="{FF2B5EF4-FFF2-40B4-BE49-F238E27FC236}">
                    <a16:creationId xmlns:a16="http://schemas.microsoft.com/office/drawing/2014/main" id="{4E6C23AC-EEFC-4739-B7E6-8E48E0DC9604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4411444" y="3666082"/>
                <a:ext cx="182250" cy="0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70B0A94B-9B36-4406-AC97-007E6955EDDC}"/>
                  </a:ext>
                </a:extLst>
              </p:cNvPr>
              <p:cNvSpPr txBox="1"/>
              <p:nvPr/>
            </p:nvSpPr>
            <p:spPr>
              <a:xfrm>
                <a:off x="4202079" y="3753076"/>
                <a:ext cx="546911" cy="3180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27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r>
                  <a:rPr lang="en-US" altLang="zh-CN" sz="83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727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lang="zh-CN" altLang="en-US" sz="83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2308494F-3CE3-4CF4-A815-EA68ED9ACCA6}"/>
                  </a:ext>
                </a:extLst>
              </p:cNvPr>
              <p:cNvSpPr txBox="1"/>
              <p:nvPr/>
            </p:nvSpPr>
            <p:spPr>
              <a:xfrm rot="16200000">
                <a:off x="4283598" y="3437673"/>
                <a:ext cx="706674" cy="2949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27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0 </a:t>
                </a:r>
                <a:r>
                  <a:rPr lang="en-US" altLang="zh-CN" sz="727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</a:t>
                </a:r>
                <a:endParaRPr lang="zh-CN" altLang="en-US" sz="727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5" name="直接连接符 54">
                <a:extLst>
                  <a:ext uri="{FF2B5EF4-FFF2-40B4-BE49-F238E27FC236}">
                    <a16:creationId xmlns:a16="http://schemas.microsoft.com/office/drawing/2014/main" id="{83054F28-339C-4D18-93D4-1E49D185C7F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07477" y="3757208"/>
                <a:ext cx="202500" cy="0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3" name="对象 2">
              <a:extLst>
                <a:ext uri="{FF2B5EF4-FFF2-40B4-BE49-F238E27FC236}">
                  <a16:creationId xmlns:a16="http://schemas.microsoft.com/office/drawing/2014/main" id="{A136F78F-D249-442E-8ABB-A2ECD4FE636D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546225" y="4027488"/>
            <a:ext cx="3127375" cy="27813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Prism 8" r:id="rId6" imgW="3974458" imgH="3531702" progId="Prism8.Document">
                    <p:embed/>
                  </p:oleObj>
                </mc:Choice>
                <mc:Fallback>
                  <p:oleObj name="Prism 8" r:id="rId6" imgW="3974458" imgH="3531702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546225" y="4027488"/>
                          <a:ext cx="3127375" cy="27813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7BC5218E-E20D-44FA-A734-551349225C94}"/>
                </a:ext>
              </a:extLst>
            </p:cNvPr>
            <p:cNvSpPr txBox="1"/>
            <p:nvPr/>
          </p:nvSpPr>
          <p:spPr>
            <a:xfrm>
              <a:off x="1148747" y="1469008"/>
              <a:ext cx="414928" cy="379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8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8">
              <a:extLst>
                <a:ext uri="{FF2B5EF4-FFF2-40B4-BE49-F238E27FC236}">
                  <a16:creationId xmlns:a16="http://schemas.microsoft.com/office/drawing/2014/main" id="{EADA17AF-CD73-401C-ABE4-C2E5CBA3F9EB}"/>
                </a:ext>
              </a:extLst>
            </p:cNvPr>
            <p:cNvSpPr txBox="1"/>
            <p:nvPr/>
          </p:nvSpPr>
          <p:spPr>
            <a:xfrm>
              <a:off x="1148747" y="3842427"/>
              <a:ext cx="373108" cy="3796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8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10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24">
              <a:extLst>
                <a:ext uri="{FF2B5EF4-FFF2-40B4-BE49-F238E27FC236}">
                  <a16:creationId xmlns:a16="http://schemas.microsoft.com/office/drawing/2014/main" id="{2B44FF34-18D6-4A49-A0A8-8D8335898ED3}"/>
                </a:ext>
              </a:extLst>
            </p:cNvPr>
            <p:cNvSpPr txBox="1"/>
            <p:nvPr/>
          </p:nvSpPr>
          <p:spPr>
            <a:xfrm>
              <a:off x="1934468" y="1576730"/>
              <a:ext cx="1040099" cy="5027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31" dirty="0">
                  <a:latin typeface="Arial" panose="020B0604020202020204" pitchFamily="34" charset="0"/>
                  <a:cs typeface="Arial" panose="020B0604020202020204" pitchFamily="34" charset="0"/>
                </a:rPr>
                <a:t>   Scramble</a:t>
              </a:r>
            </a:p>
            <a:p>
              <a:r>
                <a:rPr lang="en-US" altLang="zh-CN" sz="831" dirty="0">
                  <a:latin typeface="Arial" panose="020B0604020202020204" pitchFamily="34" charset="0"/>
                  <a:cs typeface="Arial" panose="020B0604020202020204" pitchFamily="34" charset="0"/>
                </a:rPr>
                <a:t>       Cap. </a:t>
              </a:r>
              <a:endParaRPr lang="zh-CN" altLang="en-US" sz="8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直接连接符 26">
              <a:extLst>
                <a:ext uri="{FF2B5EF4-FFF2-40B4-BE49-F238E27FC236}">
                  <a16:creationId xmlns:a16="http://schemas.microsoft.com/office/drawing/2014/main" id="{3DC11C5F-08D0-41CE-B3AE-124C41DF3059}"/>
                </a:ext>
              </a:extLst>
            </p:cNvPr>
            <p:cNvCxnSpPr/>
            <p:nvPr/>
          </p:nvCxnSpPr>
          <p:spPr>
            <a:xfrm>
              <a:off x="2331622" y="2059154"/>
              <a:ext cx="238837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文本框 27">
              <a:extLst>
                <a:ext uri="{FF2B5EF4-FFF2-40B4-BE49-F238E27FC236}">
                  <a16:creationId xmlns:a16="http://schemas.microsoft.com/office/drawing/2014/main" id="{80871695-AEB7-42DA-97D7-B8DF93B09CE9}"/>
                </a:ext>
              </a:extLst>
            </p:cNvPr>
            <p:cNvSpPr txBox="1"/>
            <p:nvPr/>
          </p:nvSpPr>
          <p:spPr>
            <a:xfrm>
              <a:off x="3011286" y="1576730"/>
              <a:ext cx="932370" cy="5027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31" dirty="0">
                  <a:latin typeface="Arial" panose="020B0604020202020204" pitchFamily="34" charset="0"/>
                  <a:cs typeface="Arial" panose="020B0604020202020204" pitchFamily="34" charset="0"/>
                </a:rPr>
                <a:t>Ac2-26</a:t>
              </a:r>
            </a:p>
            <a:p>
              <a:r>
                <a:rPr lang="en-US" altLang="zh-CN" sz="831" dirty="0">
                  <a:latin typeface="Arial" panose="020B0604020202020204" pitchFamily="34" charset="0"/>
                  <a:cs typeface="Arial" panose="020B0604020202020204" pitchFamily="34" charset="0"/>
                </a:rPr>
                <a:t>  Cap. </a:t>
              </a:r>
            </a:p>
          </p:txBody>
        </p:sp>
        <p:cxnSp>
          <p:nvCxnSpPr>
            <p:cNvPr id="64" name="直接连接符 28">
              <a:extLst>
                <a:ext uri="{FF2B5EF4-FFF2-40B4-BE49-F238E27FC236}">
                  <a16:creationId xmlns:a16="http://schemas.microsoft.com/office/drawing/2014/main" id="{C7B9E487-DD18-48AE-80B9-C5DA6EE06748}"/>
                </a:ext>
              </a:extLst>
            </p:cNvPr>
            <p:cNvCxnSpPr/>
            <p:nvPr/>
          </p:nvCxnSpPr>
          <p:spPr>
            <a:xfrm>
              <a:off x="3205891" y="2060473"/>
              <a:ext cx="238837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文本框 29">
              <a:extLst>
                <a:ext uri="{FF2B5EF4-FFF2-40B4-BE49-F238E27FC236}">
                  <a16:creationId xmlns:a16="http://schemas.microsoft.com/office/drawing/2014/main" id="{644B091F-A264-499A-B657-643C0C024464}"/>
                </a:ext>
              </a:extLst>
            </p:cNvPr>
            <p:cNvSpPr txBox="1"/>
            <p:nvPr/>
          </p:nvSpPr>
          <p:spPr>
            <a:xfrm>
              <a:off x="3730049" y="1576730"/>
              <a:ext cx="1508659" cy="5027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31" dirty="0">
                  <a:latin typeface="Arial" panose="020B0604020202020204" pitchFamily="34" charset="0"/>
                  <a:cs typeface="Arial" panose="020B0604020202020204" pitchFamily="34" charset="0"/>
                </a:rPr>
                <a:t>Boc2 + Ac2-26</a:t>
              </a:r>
            </a:p>
            <a:p>
              <a:r>
                <a:rPr lang="en-US" altLang="zh-CN" sz="831" dirty="0">
                  <a:latin typeface="Arial" panose="020B0604020202020204" pitchFamily="34" charset="0"/>
                  <a:cs typeface="Arial" panose="020B0604020202020204" pitchFamily="34" charset="0"/>
                </a:rPr>
                <a:t> Cap.</a:t>
              </a:r>
            </a:p>
          </p:txBody>
        </p:sp>
        <p:cxnSp>
          <p:nvCxnSpPr>
            <p:cNvPr id="68" name="直接连接符 30">
              <a:extLst>
                <a:ext uri="{FF2B5EF4-FFF2-40B4-BE49-F238E27FC236}">
                  <a16:creationId xmlns:a16="http://schemas.microsoft.com/office/drawing/2014/main" id="{48F8BBB7-15EA-46B9-8E25-5C5B8932C000}"/>
                </a:ext>
              </a:extLst>
            </p:cNvPr>
            <p:cNvCxnSpPr/>
            <p:nvPr/>
          </p:nvCxnSpPr>
          <p:spPr>
            <a:xfrm>
              <a:off x="3910329" y="2059154"/>
              <a:ext cx="238837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" name="矩形 4"/>
          <p:cNvSpPr/>
          <p:nvPr/>
        </p:nvSpPr>
        <p:spPr>
          <a:xfrm>
            <a:off x="3870870" y="4747644"/>
            <a:ext cx="4306688" cy="987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831" b="1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le 3</a:t>
            </a:r>
            <a:r>
              <a:rPr lang="en-US" altLang="zh-CN" sz="831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Ac2-26 inhibits TRPV1 currents via FPR2 in DRG neurons of wild type mice.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A) Whole-cell current responses to applications of capsaicin (Cap.; 100 </a:t>
            </a:r>
            <a:r>
              <a:rPr lang="en-US" altLang="zh-CN" sz="83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M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+ </a:t>
            </a:r>
            <a:r>
              <a:rPr lang="en-US" altLang="zh-CN" sz="83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amble (3.3 </a:t>
            </a:r>
            <a:r>
              <a:rPr lang="el-GR" altLang="zh-CN" sz="83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83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, 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psaicin + Ac2-26 (</a:t>
            </a:r>
            <a:r>
              <a:rPr lang="el-GR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.3 μ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) and capsaicin + Boc2 (10 </a:t>
            </a:r>
            <a:r>
              <a:rPr lang="el-GR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) + Ac2-26 (</a:t>
            </a:r>
            <a:r>
              <a:rPr lang="el-GR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.3 μ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), respectively. (B) Statistic bar graph shows the fold change peak current in (a), scramble control was normalized to 1 for comparison. (Ac2-26 versus scramble group, ****P&lt;0.0001; Ac2-26 versus Boc2+Ac2-26 group, ****P&lt;0.0001, one-way ANOVA, post hoc Tukey’s multiple comparisons test, n=10 in each group). All data are represented as mean</a:t>
            </a:r>
            <a:r>
              <a:rPr lang="zh-CN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±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D.</a:t>
            </a:r>
            <a:endParaRPr lang="zh-CN" altLang="zh-CN" sz="727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CF9F106-518D-4128-9C96-C908ED048F23}"/>
              </a:ext>
            </a:extLst>
          </p:cNvPr>
          <p:cNvSpPr txBox="1"/>
          <p:nvPr/>
        </p:nvSpPr>
        <p:spPr>
          <a:xfrm>
            <a:off x="3824458" y="176460"/>
            <a:ext cx="1285929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ditional file </a:t>
            </a:r>
            <a:r>
              <a:rPr lang="en-US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7" name="矩形 6"/>
          <p:cNvSpPr/>
          <p:nvPr/>
        </p:nvSpPr>
        <p:spPr>
          <a:xfrm>
            <a:off x="3824458" y="471191"/>
            <a:ext cx="4460484" cy="2414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69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c2-26 inhibits TRPV1 currents via FPR2 in DRG neurons of wild type mice.</a:t>
            </a:r>
            <a:r>
              <a:rPr lang="en-US" altLang="zh-CN" sz="96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en-US" sz="969" dirty="0"/>
          </a:p>
        </p:txBody>
      </p:sp>
    </p:spTree>
    <p:extLst>
      <p:ext uri="{BB962C8B-B14F-4D97-AF65-F5344CB8AC3E}">
        <p14:creationId xmlns:p14="http://schemas.microsoft.com/office/powerpoint/2010/main" val="2338871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80</Words>
  <Application>Microsoft Office PowerPoint</Application>
  <PresentationFormat>宽屏</PresentationFormat>
  <Paragraphs>14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Times New Roman</vt:lpstr>
      <vt:lpstr>Office Theme</vt:lpstr>
      <vt:lpstr>Prism 8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undarya NR.</dc:creator>
  <cp:lastModifiedBy>peilei</cp:lastModifiedBy>
  <cp:revision>4</cp:revision>
  <dcterms:created xsi:type="dcterms:W3CDTF">2021-08-17T15:13:06Z</dcterms:created>
  <dcterms:modified xsi:type="dcterms:W3CDTF">2021-08-20T05:42:54Z</dcterms:modified>
</cp:coreProperties>
</file>